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102" y="-11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Объект 2">
            <a:extLst>
              <a:ext uri="{FF2B5EF4-FFF2-40B4-BE49-F238E27FC236}">
                <a16:creationId xmlns:a16="http://schemas.microsoft.com/office/drawing/2014/main" xmlns="" id="{B5A1926C-F1CF-5BDA-0061-F4962B0CECDA}"/>
              </a:ext>
            </a:extLst>
          </p:cNvPr>
          <p:cNvSpPr txBox="1">
            <a:spLocks/>
          </p:cNvSpPr>
          <p:nvPr/>
        </p:nvSpPr>
        <p:spPr>
          <a:xfrm>
            <a:off x="169865" y="5791200"/>
            <a:ext cx="8862822" cy="9144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hematic representation of the rat brain cross-section showing localization of the region of frontal cortex and striatum selected for RNA sequencing (shaded areas).</a:t>
            </a:r>
          </a:p>
        </p:txBody>
      </p:sp>
      <p:sp>
        <p:nvSpPr>
          <p:cNvPr id="9" name="Прямоугольник 8"/>
          <p:cNvSpPr/>
          <p:nvPr/>
        </p:nvSpPr>
        <p:spPr>
          <a:xfrm>
            <a:off x="169865" y="76200"/>
            <a:ext cx="874553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ru-RU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calization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f the region of frontal cortex and striatum selected for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NA-Seq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400" b="1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pic>
        <p:nvPicPr>
          <p:cNvPr id="2" name="Picture 2" descr="K:\Редактируемые\Для публикаций\0_текущие публикации\ишемия_2\стриатум 24h\статья по 24 часам striat\1_IR Str-FC\fs1-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9609" y="1752600"/>
            <a:ext cx="7183333" cy="25241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227907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4</TotalTime>
  <Words>42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Office Them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van</dc:creator>
  <cp:lastModifiedBy>Ivan</cp:lastModifiedBy>
  <cp:revision>11</cp:revision>
  <dcterms:created xsi:type="dcterms:W3CDTF">2006-08-16T00:00:00Z</dcterms:created>
  <dcterms:modified xsi:type="dcterms:W3CDTF">2025-01-14T10:12:04Z</dcterms:modified>
</cp:coreProperties>
</file>